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677"/>
    <p:restoredTop sz="94694"/>
  </p:normalViewPr>
  <p:slideViewPr>
    <p:cSldViewPr snapToGrid="0">
      <p:cViewPr varScale="1">
        <p:scale>
          <a:sx n="79" d="100"/>
          <a:sy n="79" d="100"/>
        </p:scale>
        <p:origin x="77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43BE24-4E64-5BBD-DE7F-E72F5E5AB6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D3377D-E7BA-2976-FAE6-1070872E21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F8BBBF-EF00-3FE2-99C2-462E11FB5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86D809-7454-9737-7021-DDAA18972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56E02E-C726-3234-7736-6213B8B97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55552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F3FBD9-3539-B42F-2D08-CD3321D5FB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8BE92C-A4F3-968E-05E6-971F944FE5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9AE4CF-1EF4-1387-2E30-B02020FB6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8CE7BD-7D38-84A6-AF67-96C610F27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09F8F9-3893-8CEB-46B2-B375D8A1A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8095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59287D2-E99A-E3E3-0DAB-20D89436AD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5B4E0A-B225-51AA-BB33-E1DE22843D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BE8567-62C3-2042-CC0D-8543C7321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AEC251-AF91-F7F5-6E4A-5CE7373B3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C163A-5D44-ECDD-7740-D564CCF4F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51672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930604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FA40F2-9951-3E50-5E9E-207435CBBB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8B6DF0-1379-6C65-2130-B41F7B7F1A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1E07F0-7A85-8B65-7365-B8CC8FE0A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11784C-AFD6-42C9-8A53-8188809A5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A0FF5C-A713-B510-2D0C-BEBAFEDA3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049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F4DA6C-A6FB-706E-838E-7A55FFB505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30D365-ADB8-617A-C3FC-8E5D314BD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B02B05-D63B-EAA6-A01C-47C001F0D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F9ADC4-E05D-AE6D-5FBF-419D0AD8D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16BFC1-B298-C47F-D100-601104EA4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4641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D7E4D1-8FD6-1A4D-154B-1C211373A4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13E505-CBE6-C121-A833-38C4C31A7B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566BA-8F59-09DE-EB88-4147C2785C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AD20CA-79ED-832A-7A4A-4AEB38825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3D8972-36E2-FC3D-F6B9-40B4101CA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450F7B-5B18-D152-A2B1-BF2D77814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6369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68867-7429-3013-7A6E-ED2B3FFCE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FFD621-78CB-5BAB-2134-92350FCB1E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B36FC2-1914-10CE-AC20-FD0CB29EB9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38D6DC-D879-A3FB-EEAE-957AD9FCC7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C3428F-84E1-93AB-8E54-B5432F8354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182483A-DBAA-EDCE-3440-2E2A09471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BEE24C-F043-CEE0-B0F7-0A1CC401C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BE73D1-9C64-1056-E8A6-250726C27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0517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15C38C-40C0-8689-4A7B-3CDADFF226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3A6F8A-4087-B6BD-3CB7-8E2408085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4A7166-25C9-B2DB-2E68-CA0FD36C0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BEF254-8BF9-F2A9-2A81-7DC78A734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0648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F874E7-F844-16DC-D1C7-C9AC6D8E8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BB0028-E54B-F1B3-E5D4-43897194A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85AABF-3E05-2372-3006-96E0B7602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0501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405D79-10BF-35B9-2FE3-F650093D73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60D88-D878-58FF-7F75-B61DA84723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B9F7A5-EFD3-6AB7-D626-D23DEB0E18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7F3D17-BB97-68C8-EBB9-1347759FD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FC187E-9959-E614-1854-94622D9FA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A7F786-62B5-D136-BF9B-5B0100BE0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0956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0F3382-6561-A318-0169-DBD334F98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29FBFB-D12A-0920-F962-277115E3DB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A82409-CA1D-0BB7-1951-45C4ACB3E9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B384C0-A176-FCE3-5A31-D770E710D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49425C-7288-926E-1CB4-CBFAE9DAD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5B45AC-AD08-0718-A75B-9572ABF2A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5579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034C2EA-3566-87EB-6671-09ABFFD506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4680FC-8AB8-88E4-FD7B-741BE6EE31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9A4520-3EBF-0CA8-20BD-ACDBF989AA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E85C43-92EA-D34E-B3E3-22B2B2221D33}" type="datetimeFigureOut">
              <a:rPr lang="en-US" smtClean="0"/>
              <a:t>7/24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859C05-600C-481E-8635-71622697F1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D19BD0-39C7-BDFD-C1F8-CB42C7F19A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1475475-E214-2D4F-850C-044ABC6DA47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9470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ost-hurricane fluid conservation measures fail to reduce IV fluid use in critically ill childre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08689" y="1170419"/>
            <a:ext cx="11607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IM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Assess the impact of IV fluid conservation guidelines on cumulative fluid balance (CFB) in critically ill childre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ESIGN &amp; OUTCOMES</a:t>
            </a:r>
            <a:r>
              <a:rPr lang="en-GB" dirty="0">
                <a:solidFill>
                  <a:srgbClr val="0065A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ixon et al. 2025</a:t>
            </a:r>
            <a:endParaRPr lang="en-GB" sz="1400" b="1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3569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Even in the setting of a national IV fluid shortage, simple recommendations were insufficient to change IV fluid administration practices. Additional measures will be needed to reduce IV fluid use and positive cumulative fluid balance.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189284A-9083-84E3-45C7-91FC823963CE}"/>
              </a:ext>
            </a:extLst>
          </p:cNvPr>
          <p:cNvSpPr txBox="1"/>
          <p:nvPr/>
        </p:nvSpPr>
        <p:spPr>
          <a:xfrm>
            <a:off x="2627542" y="1796973"/>
            <a:ext cx="735017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00437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ulti-</a:t>
            </a:r>
            <a:r>
              <a:rPr lang="en-GB" sz="1600" dirty="0" err="1">
                <a:solidFill>
                  <a:srgbClr val="00437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enter</a:t>
            </a:r>
            <a:r>
              <a:rPr lang="en-GB" sz="1600" dirty="0">
                <a:solidFill>
                  <a:srgbClr val="00437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federated data network study over 2-month period at 4 pediatric ICUs</a:t>
            </a:r>
            <a:endParaRPr lang="en-GB" sz="1600" dirty="0">
              <a:solidFill>
                <a:srgbClr val="296DC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endParaRPr lang="en-GB" sz="1600" dirty="0">
              <a:solidFill>
                <a:srgbClr val="00437A"/>
              </a:solidFill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DD153EA2-8EF5-6FE4-3D2F-919E876C061C}"/>
              </a:ext>
            </a:extLst>
          </p:cNvPr>
          <p:cNvSpPr/>
          <p:nvPr/>
        </p:nvSpPr>
        <p:spPr>
          <a:xfrm>
            <a:off x="6212542" y="4963460"/>
            <a:ext cx="5979458" cy="51263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No difference in ICU Day 1 or 2 IVF intake or positive CFB between pre- and post- IVF conservation guideline implementation </a:t>
            </a: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AA81B1CE-92F5-76CE-76A5-BAF0489B3AE4}"/>
              </a:ext>
            </a:extLst>
          </p:cNvPr>
          <p:cNvGrpSpPr/>
          <p:nvPr/>
        </p:nvGrpSpPr>
        <p:grpSpPr>
          <a:xfrm>
            <a:off x="343331" y="2288318"/>
            <a:ext cx="6292559" cy="2706399"/>
            <a:chOff x="397119" y="2839645"/>
            <a:chExt cx="6292559" cy="2706399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72AB7125-1643-1EBD-932D-5C8690D1433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42791" y="2839645"/>
              <a:ext cx="717852" cy="1908216"/>
              <a:chOff x="218633" y="2532460"/>
              <a:chExt cx="940594" cy="2500315"/>
            </a:xfrm>
          </p:grpSpPr>
          <p:sp>
            <p:nvSpPr>
              <p:cNvPr id="2" name="Freeform: Shape 46">
                <a:extLst>
                  <a:ext uri="{FF2B5EF4-FFF2-40B4-BE49-F238E27FC236}">
                    <a16:creationId xmlns:a16="http://schemas.microsoft.com/office/drawing/2014/main" id="{D2538D64-0BF3-786A-2F8C-1292D30A4AB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18633" y="2532460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7" name="Freeform: Shape 46">
                <a:extLst>
                  <a:ext uri="{FF2B5EF4-FFF2-40B4-BE49-F238E27FC236}">
                    <a16:creationId xmlns:a16="http://schemas.microsoft.com/office/drawing/2014/main" id="{4722E112-AFB9-8D14-8588-2D1995CF3F4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45943" y="2879001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296DC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8" name="Freeform: Shape 46">
                <a:extLst>
                  <a:ext uri="{FF2B5EF4-FFF2-40B4-BE49-F238E27FC236}">
                    <a16:creationId xmlns:a16="http://schemas.microsoft.com/office/drawing/2014/main" id="{70AD9462-93BD-A17A-7BA7-2F2083B4B30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18633" y="3636336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65AA0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9" name="Freeform: Shape 46">
                <a:extLst>
                  <a:ext uri="{FF2B5EF4-FFF2-40B4-BE49-F238E27FC236}">
                    <a16:creationId xmlns:a16="http://schemas.microsoft.com/office/drawing/2014/main" id="{31A5F150-E937-8EAB-8D5C-50CA574662D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45943" y="3982877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AA0065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385037A6-3000-1591-C73E-A4911D5451D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689963" y="2951286"/>
              <a:ext cx="717852" cy="1908216"/>
              <a:chOff x="218633" y="2532460"/>
              <a:chExt cx="940594" cy="2500315"/>
            </a:xfrm>
          </p:grpSpPr>
          <p:sp>
            <p:nvSpPr>
              <p:cNvPr id="14" name="Freeform: Shape 46">
                <a:extLst>
                  <a:ext uri="{FF2B5EF4-FFF2-40B4-BE49-F238E27FC236}">
                    <a16:creationId xmlns:a16="http://schemas.microsoft.com/office/drawing/2014/main" id="{8BD869CF-59B1-334E-3A98-198AFA34391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18633" y="2532460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15" name="Freeform: Shape 46">
                <a:extLst>
                  <a:ext uri="{FF2B5EF4-FFF2-40B4-BE49-F238E27FC236}">
                    <a16:creationId xmlns:a16="http://schemas.microsoft.com/office/drawing/2014/main" id="{F0A61EFF-8386-CD22-911A-6DF4935C043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45943" y="2879001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296DC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16" name="Freeform: Shape 46">
                <a:extLst>
                  <a:ext uri="{FF2B5EF4-FFF2-40B4-BE49-F238E27FC236}">
                    <a16:creationId xmlns:a16="http://schemas.microsoft.com/office/drawing/2014/main" id="{ABA26E0A-FDC2-E281-A8A1-D7A082244D56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18633" y="3636336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65AA0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17" name="Freeform: Shape 46">
                <a:extLst>
                  <a:ext uri="{FF2B5EF4-FFF2-40B4-BE49-F238E27FC236}">
                    <a16:creationId xmlns:a16="http://schemas.microsoft.com/office/drawing/2014/main" id="{0BE3D0FE-B7BE-5789-F120-5D837639882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45943" y="3982877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AA0065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</p:grp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4EDB2ED8-7347-43A0-92A1-C41EB75A04D0}"/>
                </a:ext>
              </a:extLst>
            </p:cNvPr>
            <p:cNvCxnSpPr>
              <a:cxnSpLocks/>
            </p:cNvCxnSpPr>
            <p:nvPr/>
          </p:nvCxnSpPr>
          <p:spPr>
            <a:xfrm>
              <a:off x="1572100" y="3952629"/>
              <a:ext cx="3058232" cy="0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non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1E94676A-B768-ED2A-0BE4-23F10254D7DC}"/>
                </a:ext>
              </a:extLst>
            </p:cNvPr>
            <p:cNvCxnSpPr>
              <a:cxnSpLocks/>
            </p:cNvCxnSpPr>
            <p:nvPr/>
          </p:nvCxnSpPr>
          <p:spPr>
            <a:xfrm>
              <a:off x="5467446" y="4003344"/>
              <a:ext cx="1222232" cy="21327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Up Arrow 19">
              <a:extLst>
                <a:ext uri="{FF2B5EF4-FFF2-40B4-BE49-F238E27FC236}">
                  <a16:creationId xmlns:a16="http://schemas.microsoft.com/office/drawing/2014/main" id="{2D0C3431-B277-8985-EDA2-AAF8D290D1F9}"/>
                </a:ext>
              </a:extLst>
            </p:cNvPr>
            <p:cNvSpPr/>
            <p:nvPr/>
          </p:nvSpPr>
          <p:spPr>
            <a:xfrm rot="10800000">
              <a:off x="4168520" y="3414254"/>
              <a:ext cx="301374" cy="524454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AA006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ABC7D55-564F-BBF7-36DD-8BE34851FBB8}"/>
                </a:ext>
              </a:extLst>
            </p:cNvPr>
            <p:cNvSpPr txBox="1"/>
            <p:nvPr/>
          </p:nvSpPr>
          <p:spPr>
            <a:xfrm>
              <a:off x="2442660" y="2854764"/>
              <a:ext cx="221647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400" dirty="0">
                  <a:solidFill>
                    <a:srgbClr val="AA0065"/>
                  </a:solidFill>
                </a:rPr>
                <a:t>Implementation of IVF conservation guidelines after Hurricane Helene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7851E46A-D3D8-1084-6BEE-AB1FBC8BA254}"/>
                </a:ext>
              </a:extLst>
            </p:cNvPr>
            <p:cNvSpPr/>
            <p:nvPr/>
          </p:nvSpPr>
          <p:spPr>
            <a:xfrm>
              <a:off x="397119" y="4876107"/>
              <a:ext cx="1735313" cy="622841"/>
            </a:xfrm>
            <a:prstGeom prst="rect">
              <a:avLst/>
            </a:prstGeom>
            <a:noFill/>
            <a:ln w="41275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rgbClr val="296DC0"/>
                  </a:solidFill>
                </a:rPr>
                <a:t>Pre-IVF conservation cohort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84AAC53D-8271-22BC-6CCB-0ECFDBBC54A3}"/>
                </a:ext>
              </a:extLst>
            </p:cNvPr>
            <p:cNvSpPr/>
            <p:nvPr/>
          </p:nvSpPr>
          <p:spPr>
            <a:xfrm>
              <a:off x="4155378" y="4923203"/>
              <a:ext cx="1735313" cy="622841"/>
            </a:xfrm>
            <a:prstGeom prst="rect">
              <a:avLst/>
            </a:prstGeom>
            <a:noFill/>
            <a:ln w="41275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rgbClr val="296DC0"/>
                  </a:solidFill>
                </a:rPr>
                <a:t>Post-IVF conservation cohor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95B54C3-7B34-646C-D58D-D57505A73EBA}"/>
                </a:ext>
              </a:extLst>
            </p:cNvPr>
            <p:cNvSpPr txBox="1"/>
            <p:nvPr/>
          </p:nvSpPr>
          <p:spPr>
            <a:xfrm>
              <a:off x="2630708" y="4969765"/>
              <a:ext cx="102639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>
                  <a:solidFill>
                    <a:srgbClr val="AA0065"/>
                  </a:solidFill>
                </a:rPr>
                <a:t>versus</a:t>
              </a:r>
            </a:p>
          </p:txBody>
        </p:sp>
      </p:grpSp>
      <p:graphicFrame>
        <p:nvGraphicFramePr>
          <p:cNvPr id="40" name="Table 39">
            <a:extLst>
              <a:ext uri="{FF2B5EF4-FFF2-40B4-BE49-F238E27FC236}">
                <a16:creationId xmlns:a16="http://schemas.microsoft.com/office/drawing/2014/main" id="{5C75F1E5-FCDF-B9B2-188A-B747619397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3054318"/>
              </p:ext>
            </p:extLst>
          </p:nvPr>
        </p:nvGraphicFramePr>
        <p:xfrm>
          <a:off x="6818920" y="2315260"/>
          <a:ext cx="5116245" cy="2381216"/>
        </p:xfrm>
        <a:graphic>
          <a:graphicData uri="http://schemas.openxmlformats.org/drawingml/2006/table">
            <a:tbl>
              <a:tblPr firstRow="1" firstCol="1" bandRow="1">
                <a:tableStyleId>{BC89EF96-8CEA-46FF-86C4-4CE0E7609802}</a:tableStyleId>
              </a:tblPr>
              <a:tblGrid>
                <a:gridCol w="1419802">
                  <a:extLst>
                    <a:ext uri="{9D8B030D-6E8A-4147-A177-3AD203B41FA5}">
                      <a16:colId xmlns:a16="http://schemas.microsoft.com/office/drawing/2014/main" val="3743646251"/>
                    </a:ext>
                  </a:extLst>
                </a:gridCol>
                <a:gridCol w="462530">
                  <a:extLst>
                    <a:ext uri="{9D8B030D-6E8A-4147-A177-3AD203B41FA5}">
                      <a16:colId xmlns:a16="http://schemas.microsoft.com/office/drawing/2014/main" val="4029286014"/>
                    </a:ext>
                  </a:extLst>
                </a:gridCol>
                <a:gridCol w="458733">
                  <a:extLst>
                    <a:ext uri="{9D8B030D-6E8A-4147-A177-3AD203B41FA5}">
                      <a16:colId xmlns:a16="http://schemas.microsoft.com/office/drawing/2014/main" val="219981718"/>
                    </a:ext>
                  </a:extLst>
                </a:gridCol>
                <a:gridCol w="462530">
                  <a:extLst>
                    <a:ext uri="{9D8B030D-6E8A-4147-A177-3AD203B41FA5}">
                      <a16:colId xmlns:a16="http://schemas.microsoft.com/office/drawing/2014/main" val="71938612"/>
                    </a:ext>
                  </a:extLst>
                </a:gridCol>
                <a:gridCol w="462530">
                  <a:extLst>
                    <a:ext uri="{9D8B030D-6E8A-4147-A177-3AD203B41FA5}">
                      <a16:colId xmlns:a16="http://schemas.microsoft.com/office/drawing/2014/main" val="947058977"/>
                    </a:ext>
                  </a:extLst>
                </a:gridCol>
                <a:gridCol w="462530">
                  <a:extLst>
                    <a:ext uri="{9D8B030D-6E8A-4147-A177-3AD203B41FA5}">
                      <a16:colId xmlns:a16="http://schemas.microsoft.com/office/drawing/2014/main" val="3240520183"/>
                    </a:ext>
                  </a:extLst>
                </a:gridCol>
                <a:gridCol w="462530">
                  <a:extLst>
                    <a:ext uri="{9D8B030D-6E8A-4147-A177-3AD203B41FA5}">
                      <a16:colId xmlns:a16="http://schemas.microsoft.com/office/drawing/2014/main" val="1541740706"/>
                    </a:ext>
                  </a:extLst>
                </a:gridCol>
                <a:gridCol w="462530">
                  <a:extLst>
                    <a:ext uri="{9D8B030D-6E8A-4147-A177-3AD203B41FA5}">
                      <a16:colId xmlns:a16="http://schemas.microsoft.com/office/drawing/2014/main" val="1835818952"/>
                    </a:ext>
                  </a:extLst>
                </a:gridCol>
                <a:gridCol w="462530">
                  <a:extLst>
                    <a:ext uri="{9D8B030D-6E8A-4147-A177-3AD203B41FA5}">
                      <a16:colId xmlns:a16="http://schemas.microsoft.com/office/drawing/2014/main" val="4108080863"/>
                    </a:ext>
                  </a:extLst>
                </a:gridCol>
              </a:tblGrid>
              <a:tr h="26439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</a:p>
                  </a:txBody>
                  <a:tcPr marL="68580" marR="68580" marT="0" marB="0" anchor="ctr">
                    <a:solidFill>
                      <a:schemeClr val="accent1">
                        <a:alpha val="4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Site 1</a:t>
                      </a:r>
                      <a:endParaRPr lang="en-US" sz="1200" dirty="0"/>
                    </a:p>
                  </a:txBody>
                  <a:tcPr marL="68580" marR="68580" marT="0" marB="0" anchor="ctr">
                    <a:solidFill>
                      <a:schemeClr val="accent1">
                        <a:alpha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Site 2</a:t>
                      </a:r>
                      <a:endParaRPr lang="en-US" sz="1200" dirty="0"/>
                    </a:p>
                  </a:txBody>
                  <a:tcPr marL="68580" marR="68580" marT="0" marB="0" anchor="ctr">
                    <a:solidFill>
                      <a:schemeClr val="accent1">
                        <a:alpha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Site 2</a:t>
                      </a:r>
                      <a:endParaRPr lang="en-US"/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Site 3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alpha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Site 4</a:t>
                      </a:r>
                      <a:endParaRPr lang="en-US" sz="1200" dirty="0"/>
                    </a:p>
                  </a:txBody>
                  <a:tcPr marL="68580" marR="68580" marT="0" marB="0" anchor="ctr">
                    <a:solidFill>
                      <a:schemeClr val="accent1">
                        <a:alpha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00" kern="100">
                          <a:effectLst/>
                        </a:rPr>
                        <a:t>Site 4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50514727"/>
                  </a:ext>
                </a:extLst>
              </a:tr>
              <a:tr h="26606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 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Pre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Post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Pre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Post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Pre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Post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Pre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Post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85715785"/>
                  </a:ext>
                </a:extLst>
              </a:tr>
              <a:tr h="26439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ICU Admissions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80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104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338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300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75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88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140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127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22280011"/>
                  </a:ext>
                </a:extLst>
              </a:tr>
              <a:tr h="264394">
                <a:tc gridSpan="9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Median Total IV Intake (ml/kg/</a:t>
                      </a:r>
                      <a:r>
                        <a:rPr lang="en-US" sz="1200" kern="100" dirty="0" err="1">
                          <a:effectLst/>
                        </a:rPr>
                        <a:t>hr</a:t>
                      </a:r>
                      <a:r>
                        <a:rPr lang="en-US" sz="1200" kern="100" dirty="0">
                          <a:effectLst/>
                        </a:rPr>
                        <a:t>)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8090719"/>
                  </a:ext>
                </a:extLst>
              </a:tr>
              <a:tr h="26439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     ICU Day 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1.5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1.44</a:t>
                      </a:r>
                      <a:endParaRPr lang="en-US" sz="1200" dirty="0"/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</a:rPr>
                        <a:t>1.74</a:t>
                      </a:r>
                      <a:endParaRPr lang="en-US" sz="1200" dirty="0"/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1.5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2.75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2.13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effectLst/>
                        </a:rPr>
                        <a:t>1.3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0.94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6172215"/>
                  </a:ext>
                </a:extLst>
              </a:tr>
              <a:tr h="26439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     ICU Day 2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0.9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1.44</a:t>
                      </a:r>
                      <a:endParaRPr lang="en-US" sz="1200" dirty="0"/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1.00</a:t>
                      </a:r>
                      <a:endParaRPr lang="en-US" sz="1200" dirty="0"/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1.02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1.5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1.1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1.3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1.0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4241983"/>
                  </a:ext>
                </a:extLst>
              </a:tr>
              <a:tr h="264394">
                <a:tc gridSpan="9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&gt;10% </a:t>
                      </a:r>
                      <a:r>
                        <a:rPr lang="en-US" sz="1200" kern="100">
                          <a:effectLst/>
                        </a:rPr>
                        <a:t>Positive CFB (n)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alpha val="2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764690"/>
                  </a:ext>
                </a:extLst>
              </a:tr>
              <a:tr h="26439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     ICU Day 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2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16</a:t>
                      </a:r>
                      <a:endParaRPr lang="en-US" sz="1200" dirty="0"/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2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3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8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8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2524830"/>
                  </a:ext>
                </a:extLst>
              </a:tr>
              <a:tr h="26439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     ICU Day 2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5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5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</a:rPr>
                        <a:t>26 </a:t>
                      </a:r>
                      <a:endParaRPr lang="en-US" sz="1200" dirty="0"/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3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9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</a:rPr>
                        <a:t>1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636377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227</Words>
  <Application>Microsoft Office PowerPoint</Application>
  <PresentationFormat>Widescreen</PresentationFormat>
  <Paragraphs>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ixon, Celeste</dc:creator>
  <cp:lastModifiedBy>Bob Thompson</cp:lastModifiedBy>
  <cp:revision>3</cp:revision>
  <dcterms:created xsi:type="dcterms:W3CDTF">2025-04-17T01:14:47Z</dcterms:created>
  <dcterms:modified xsi:type="dcterms:W3CDTF">2025-07-24T19:13:19Z</dcterms:modified>
</cp:coreProperties>
</file>